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8B36A5-A74C-4104-B8EC-CB1EF60956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D4253FD-1B5F-4FBF-B615-D481B23EE0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E75D1F-9B49-4C31-A8E5-1F65F0451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E30187-9065-47FA-AE0B-F3C15AA61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893E3A-9968-4DD1-ACC2-858329916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5867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BFC8C4-5895-483B-8FD6-8F35C08D5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1989A16-B7C1-4B83-8022-197A4117DD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4F9D9-6C99-4663-9E62-0F234FF4E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A03BBF-B35C-477B-83A1-2AC580CF4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4496C6-1FEC-44B6-B71F-BB6D4BC6E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354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2994C9B-6C76-49AF-A583-F7CAC0C82D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D7C1B50-DF1A-47CC-97E1-1C1235B566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B34F4F-639C-4931-A923-2B0DBDD88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900523-8667-4BF2-8F86-4F88966DF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663BCA-883F-411B-B0E5-BFF0729F0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5159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6F7D0E-CF94-4A6B-8981-71BB59D4A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EB1AE3-2C57-4FD2-95C7-EF15811F78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F1D27-054B-4255-A301-27AB33421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A53EDA-31FD-42B1-A80C-09205D0D5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05BEDD-D885-4DC3-9285-CD428F3DB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789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A67DF3-DC6A-4315-8024-13EC59F72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15721F-9615-488D-8D91-A6BB3D718B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DA565B-78CE-40B1-8DEE-379D6B34B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C1FDCE-09AC-4265-967D-546719F01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F6A25E-AE52-4848-B8FB-1123A44A7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231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EDC0EF-14EB-49CE-8955-175D5E0EB6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45329A-4809-4C43-97B0-D4063EB97A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B7026C-F1CA-4637-9680-A4092A7502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A2856C-FF37-460C-86B8-8E26FD8B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E81902-1B5A-482D-A40B-F1F803CBF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D19935-2934-4E9F-86D8-661C7E106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6512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9A96BD-8779-45BF-8FEC-62F2B3A091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AACBBB-3480-4402-AAA4-36FADC70F1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DBD5E3-DA8D-4025-BE74-24712ECF67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6CBFF3C-6D97-4050-803F-6FCE0ECD61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5AAE50E-D75F-4C4B-BF26-9C60AC1F7E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466EC62-93FC-4913-BE06-69345AD36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52CAC8A-F678-4326-96D4-F37893EDF8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CB8A5DA-354A-4859-B01C-081625247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3786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095DCB-8DFC-4AA7-8F00-C4C344176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E278C66-E28E-41AF-8386-EF7CC5BBD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A5E5BAA-5314-4C96-BA97-DFE136333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3AA572E-5CBB-4CF1-BB6B-40E592B50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941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273E62B-35D1-4D72-8101-127F40156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EF9288F-41B3-4EE5-8CDD-8E0BC2EA4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BF7EC71-B3B6-4E5A-971A-D3770FC1E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166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C67C3-EC47-485F-ADDC-A32BC663EE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5DD224-B35C-484C-82AB-6C70142E4A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2A05F5-2B04-423B-9F6C-721F826E29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79BC51-47D5-4512-990B-68399B411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01F3AC-67FF-4074-B01E-CC0EDD644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94D1CF-F96B-45EC-9572-F41086573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5410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EC6FDB-4D22-4821-B3AE-6A1CE4431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EB2265C-16D2-4544-BF22-C04A3E844E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7178ACA-5991-422A-B26F-7EE52ABB4E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FF09B1-B1CA-4093-AC6D-236439E2E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DCAF48-04F1-4B29-9C9D-7D88C1AF1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5AD80E-503C-4622-8A64-58E5C729A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904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BEEBE1E-EB7C-43EC-A21A-BE4A21CAB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33DA89-E791-4151-94D2-5C7D250F13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A5212D-A264-4DE9-BA6B-A2585D9D84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4A2F1-249F-4146-B4DF-AE01A0EAA9C1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FC72E3-E123-4D31-BA9F-47781D23EF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F7E76F-D98C-4820-B8A1-BDE397B634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0176D-6F30-4BF2-9FBD-40237950EC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221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CA13A97-9596-46F0-8931-CF67315F5F3D}"/>
              </a:ext>
            </a:extLst>
          </p:cNvPr>
          <p:cNvSpPr txBox="1"/>
          <p:nvPr/>
        </p:nvSpPr>
        <p:spPr>
          <a:xfrm>
            <a:off x="339568" y="125104"/>
            <a:ext cx="6178677" cy="405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4. Histological assessment of liver in NASH mice after intervention stained with oil red O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FD2E6DF-DB58-405B-AE7E-5F121EB1CAB3}"/>
              </a:ext>
            </a:extLst>
          </p:cNvPr>
          <p:cNvSpPr txBox="1"/>
          <p:nvPr/>
        </p:nvSpPr>
        <p:spPr>
          <a:xfrm>
            <a:off x="79410" y="6142971"/>
            <a:ext cx="1173036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1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tervention groups: EHFD, exercise plus high fat diet; ELFD, exercise plus low fat diet; HFD, high fat diet; LFD, low fat diet; intervention groups: MCD, methionine choline deficiency diet (8 weeks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)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 Scale bars = 100 </a:t>
            </a:r>
            <a:r>
              <a:rPr lang="el-GR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μ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.</a:t>
            </a:r>
            <a:endParaRPr lang="zh-CN" altLang="en-US" sz="1200" dirty="0"/>
          </a:p>
          <a:p>
            <a:pPr algn="just"/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4AC80D0-74B8-4DDE-AD0E-9E75711EE4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5835" y="713064"/>
            <a:ext cx="2938382" cy="52473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3526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70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 Na</dc:creator>
  <cp:lastModifiedBy>Wu Na</cp:lastModifiedBy>
  <cp:revision>3</cp:revision>
  <dcterms:created xsi:type="dcterms:W3CDTF">2021-08-16T11:14:17Z</dcterms:created>
  <dcterms:modified xsi:type="dcterms:W3CDTF">2021-08-16T11:47:43Z</dcterms:modified>
</cp:coreProperties>
</file>